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  <p:sldId id="259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49"/>
    <p:restoredTop sz="94694"/>
  </p:normalViewPr>
  <p:slideViewPr>
    <p:cSldViewPr snapToGrid="0">
      <p:cViewPr varScale="1">
        <p:scale>
          <a:sx n="117" d="100"/>
          <a:sy n="117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26FD164-2E48-4082-A34B-F862BC7FE6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E1A7B0B-2708-AA5F-5FDE-3C04CA51D6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94A4F89-9F25-FC90-97AC-32ABEE1C5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BFDB247-7A7C-9A6A-2574-672CDAFCA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EE9B683-0D90-20BC-02FA-76194CBCB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6669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379C4C-5DE5-E96B-171F-A85163697A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8F9B297-2913-04F3-719B-89AE01B96E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7DC5834-E389-B524-14C6-0597C95C8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AB228F-6B80-F0BA-4652-29515EE0D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54997FE-5E80-BFB5-9385-A9B116655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5863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757294B9-7F99-FC3A-F606-A854A46833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740138C-EBB0-B865-8A16-9DCF788C3F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CBA5915-80DA-79B1-71D2-14BDDC2AF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0F998CB-25F0-DC9C-B816-816AFAAA7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47312EF-9929-D0AE-E408-2586682E2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8590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F0200A-7158-4869-3131-145AFA4226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9F7BCE3-31D2-EC10-DD8C-6CB7CB2B12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C584F9C-70AC-AAAE-4E1E-9AE74F14E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AB1F4CD-2879-D37D-52D4-56D365F40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DACECE6-F5B5-7484-1F4D-635E7D7A4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6457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30A084-412F-59FF-DDCD-F88810DBE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BB3452E-AEA5-DE07-43BD-251D576461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1452572-31EC-04A2-D1FB-EBB2A6ECE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88C446B-B408-DBDC-4DF2-1A28CA2CA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FABA41-8EDC-597E-2EA6-C3443EF49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1109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6C53473-84FF-AEC3-D555-B8D92A89F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3217128-FB21-2D25-FC44-069AE1647E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4278022-9CE2-06FB-79A8-143180A66D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570EE8D-DB26-E0AC-45EF-8689C2E48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D95E17-7CAF-8CD9-F9D1-5F434C3C3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152A1B0-69C8-22AE-3664-23461D774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9439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FCBCE8-9A08-9100-660C-D142EC7E79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9177490-1738-B844-1812-2DE1DBBB4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E5C1557-D088-CD33-608D-ECA68D7A7E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0511FC5-A315-8F20-2492-9E70E1F80D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F7D94FA-A2FA-495E-D68D-B41250516D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469582D-550C-EA38-E80C-8358D5815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A40DC86-FBF4-FA39-CD57-7DA6A6438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11DB1F9-482C-A05B-1DE5-EC8261DA8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2065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CBB349B-F721-BF58-ADDD-8591120FAA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43752D4C-3E42-E88C-18C1-B16C1CB3B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12EEF66-EB95-B9D3-FBF6-47D3E63F3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194C642-9138-4901-1E30-5BA72B8C16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6933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B4F5521-D024-E43E-2A57-DF70C27AB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92E4F52-4786-86F7-1518-7F146FD8C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5F9E005-6481-561C-4CC7-FB7A8146C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9988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5FF5ED4-877B-F1BB-6F9C-5EFFF61A8E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1250360-367E-34BB-8895-6ACC3D593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6579550-18B2-3760-D3A5-09B7ECAA05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0CDB511-0316-0DD8-6F5C-34003AA73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9CA15AA-C476-166A-A6A5-1399F545D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14B55B9-B0E9-7784-6594-FEAC09FEC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8464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960650A-520D-0D9E-75E2-784CBA52B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8308C20-48F7-907E-7073-DCC5ECF965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138DB64-D380-03DE-7084-3A2A43261C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5E5D753-6151-6484-B725-21C8B50E1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91F804D-0247-58D4-B450-2DB4C06A5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669EA19-BC60-63B5-30C8-7B67E40C5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4634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726B064-6A5A-474E-9148-18EF9C2FB3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AF03204-2536-DA33-3A73-B80A8627B7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2F898AB-823F-7728-D58F-5F1D6BA00C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E08FDC-27B3-464A-A108-6117E0BC0558}" type="datetimeFigureOut">
              <a:t>16/0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D66561B-BD28-C5C8-8174-7A3B83A383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D7B17B-80CB-398C-07F9-E64C3532F0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52D39C-14B9-6043-9E5A-A72F0A79E05F}" type="slidenum"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4150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4F657909-1541-CCB1-7A6F-40F987883B40}"/>
              </a:ext>
            </a:extLst>
          </p:cNvPr>
          <p:cNvSpPr txBox="1"/>
          <p:nvPr/>
        </p:nvSpPr>
        <p:spPr>
          <a:xfrm>
            <a:off x="333576" y="5403040"/>
            <a:ext cx="115349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</a:t>
            </a:r>
            <a:r>
              <a:rPr lang="it-IT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Materials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Fig. S1. 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Endopeptidase activity of various amounts of pure bromelain. In the used experimental conditions the enzymatic activity is linear between 10 and 100 </a:t>
            </a:r>
            <a:r>
              <a:rPr lang="it-IT" sz="12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g of bromelain.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 </a:t>
            </a:r>
          </a:p>
        </p:txBody>
      </p:sp>
      <p:pic>
        <p:nvPicPr>
          <p:cNvPr id="3" name="Immagine 2" descr="Immagine che contiene linea, diagramma, Diagramma, Parallelo&#10;&#10;Descrizione generata automaticamente">
            <a:extLst>
              <a:ext uri="{FF2B5EF4-FFF2-40B4-BE49-F238E27FC236}">
                <a16:creationId xmlns:a16="http://schemas.microsoft.com/office/drawing/2014/main" id="{BB7841BC-384D-5543-8514-4B2FA46ADE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2086" y="332286"/>
            <a:ext cx="7369628" cy="49744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86063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sellaDiTesto 8">
            <a:extLst>
              <a:ext uri="{FF2B5EF4-FFF2-40B4-BE49-F238E27FC236}">
                <a16:creationId xmlns:a16="http://schemas.microsoft.com/office/drawing/2014/main" id="{624BE017-088D-7561-DB78-C28E1BA03AC5}"/>
              </a:ext>
            </a:extLst>
          </p:cNvPr>
          <p:cNvSpPr txBox="1"/>
          <p:nvPr/>
        </p:nvSpPr>
        <p:spPr>
          <a:xfrm>
            <a:off x="333576" y="5403040"/>
            <a:ext cx="11534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</a:t>
            </a:r>
            <a:r>
              <a:rPr lang="it-IT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Materials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Fig. S2. 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Endopeptidase activity of purified spores of SF174.</a:t>
            </a:r>
            <a:endParaRPr lang="it-IT" sz="12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2" name="Immagine 1" descr="Immagine che contiene testo, schermata, diagramma, numero&#10;&#10;Descrizione generata automaticamente">
            <a:extLst>
              <a:ext uri="{FF2B5EF4-FFF2-40B4-BE49-F238E27FC236}">
                <a16:creationId xmlns:a16="http://schemas.microsoft.com/office/drawing/2014/main" id="{4CB2F641-4740-36A1-48B1-85B238360C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6113" y="579986"/>
            <a:ext cx="6207257" cy="4810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4854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EFE0E48-7F97-274F-300A-EAF41B68C0C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0678B1AD-CABD-05CC-4EB3-B509D76F0E61}"/>
              </a:ext>
            </a:extLst>
          </p:cNvPr>
          <p:cNvSpPr txBox="1"/>
          <p:nvPr/>
        </p:nvSpPr>
        <p:spPr>
          <a:xfrm>
            <a:off x="333576" y="5403040"/>
            <a:ext cx="115349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</a:t>
            </a:r>
            <a:r>
              <a:rPr lang="it-IT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Materials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Fig. S3. </a:t>
            </a:r>
            <a:r>
              <a:rPr lang="it-IT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Endopeptidase activity of various amounts of a food-grade, commercial preparation of bromelain. In the used experimental conditions the enzymatic activity is linear between 0.5 and 2.5 mg of bromelain.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 </a:t>
            </a:r>
          </a:p>
        </p:txBody>
      </p:sp>
      <p:pic>
        <p:nvPicPr>
          <p:cNvPr id="3" name="Immagine 2" descr="Immagine che contiene linea, testo, Diagramma, diagramma&#10;&#10;Descrizione generata automaticamente">
            <a:extLst>
              <a:ext uri="{FF2B5EF4-FFF2-40B4-BE49-F238E27FC236}">
                <a16:creationId xmlns:a16="http://schemas.microsoft.com/office/drawing/2014/main" id="{38AD0155-881B-1BA4-3390-4C296CAA39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2601" y="370756"/>
            <a:ext cx="7102286" cy="4794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14823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85</Words>
  <Application>Microsoft Macintosh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Palatino Linotype</vt:lpstr>
      <vt:lpstr>Symbol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ZIO RICCA</dc:creator>
  <cp:lastModifiedBy>EZIO RICCA</cp:lastModifiedBy>
  <cp:revision>8</cp:revision>
  <dcterms:created xsi:type="dcterms:W3CDTF">2024-11-30T14:48:49Z</dcterms:created>
  <dcterms:modified xsi:type="dcterms:W3CDTF">2025-01-16T13:08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ad0b24d-6422-44b0-b3de-abb3a9e8c81a_Enabled">
    <vt:lpwstr>true</vt:lpwstr>
  </property>
  <property fmtid="{D5CDD505-2E9C-101B-9397-08002B2CF9AE}" pid="3" name="MSIP_Label_2ad0b24d-6422-44b0-b3de-abb3a9e8c81a_SetDate">
    <vt:lpwstr>2024-11-30T15:04:31Z</vt:lpwstr>
  </property>
  <property fmtid="{D5CDD505-2E9C-101B-9397-08002B2CF9AE}" pid="4" name="MSIP_Label_2ad0b24d-6422-44b0-b3de-abb3a9e8c81a_Method">
    <vt:lpwstr>Standard</vt:lpwstr>
  </property>
  <property fmtid="{D5CDD505-2E9C-101B-9397-08002B2CF9AE}" pid="5" name="MSIP_Label_2ad0b24d-6422-44b0-b3de-abb3a9e8c81a_Name">
    <vt:lpwstr>defa4170-0d19-0005-0004-bc88714345d2</vt:lpwstr>
  </property>
  <property fmtid="{D5CDD505-2E9C-101B-9397-08002B2CF9AE}" pid="6" name="MSIP_Label_2ad0b24d-6422-44b0-b3de-abb3a9e8c81a_SiteId">
    <vt:lpwstr>2fcfe26a-bb62-46b0-b1e3-28f9da0c45fd</vt:lpwstr>
  </property>
  <property fmtid="{D5CDD505-2E9C-101B-9397-08002B2CF9AE}" pid="7" name="MSIP_Label_2ad0b24d-6422-44b0-b3de-abb3a9e8c81a_ActionId">
    <vt:lpwstr>1b9495cf-caa2-4432-873d-281cc5c18af1</vt:lpwstr>
  </property>
  <property fmtid="{D5CDD505-2E9C-101B-9397-08002B2CF9AE}" pid="8" name="MSIP_Label_2ad0b24d-6422-44b0-b3de-abb3a9e8c81a_ContentBits">
    <vt:lpwstr>0</vt:lpwstr>
  </property>
</Properties>
</file>